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3" autoAdjust="0"/>
    <p:restoredTop sz="94660"/>
  </p:normalViewPr>
  <p:slideViewPr>
    <p:cSldViewPr snapToGrid="0">
      <p:cViewPr>
        <p:scale>
          <a:sx n="66" d="100"/>
          <a:sy n="66" d="100"/>
        </p:scale>
        <p:origin x="2016" y="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500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922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230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729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421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650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512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536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193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143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636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BD01C-7368-460C-B6EF-0BEE0E569F21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1A36E-50AC-4D05-9C9E-DBC9C22A2A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5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/>
          <p:cNvSpPr/>
          <p:nvPr/>
        </p:nvSpPr>
        <p:spPr>
          <a:xfrm>
            <a:off x="0" y="2924920"/>
            <a:ext cx="59225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ure 1. 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ucture of generation 4 hydroxyl-terminated poly(amidoamine) dendrimer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representation and sizes of generation 4 (G4) and generation 6 (G6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) dendrimers.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17138BC-60AC-487E-A00E-2172D2C137D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59282" b="59662"/>
          <a:stretch/>
        </p:blipFill>
        <p:spPr>
          <a:xfrm>
            <a:off x="289561" y="424020"/>
            <a:ext cx="1729577" cy="173859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6EB05FD-EEC1-4B86-B561-C49344768F5D}"/>
              </a:ext>
            </a:extLst>
          </p:cNvPr>
          <p:cNvSpPr txBox="1"/>
          <p:nvPr/>
        </p:nvSpPr>
        <p:spPr>
          <a:xfrm>
            <a:off x="0" y="304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3C669B4-FC13-49AA-A87A-11B3467EB2A2}"/>
              </a:ext>
            </a:extLst>
          </p:cNvPr>
          <p:cNvSpPr/>
          <p:nvPr/>
        </p:nvSpPr>
        <p:spPr>
          <a:xfrm>
            <a:off x="1" y="2123998"/>
            <a:ext cx="230869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/>
              <a:t>Generation 4 Poly(amidoamine) Dendrimer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9280EDE-3C42-4E7F-BA71-47E1558908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5953" y="51815"/>
            <a:ext cx="2487320" cy="2483001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CDBCD7F9-F37B-4BFF-BF72-43301245A558}"/>
              </a:ext>
            </a:extLst>
          </p:cNvPr>
          <p:cNvSpPr txBox="1"/>
          <p:nvPr/>
        </p:nvSpPr>
        <p:spPr>
          <a:xfrm>
            <a:off x="2308698" y="304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CAFCE054-5E5E-4735-B267-A2BAE22E994F}"/>
              </a:ext>
            </a:extLst>
          </p:cNvPr>
          <p:cNvCxnSpPr>
            <a:cxnSpLocks/>
          </p:cNvCxnSpPr>
          <p:nvPr/>
        </p:nvCxnSpPr>
        <p:spPr>
          <a:xfrm>
            <a:off x="3633216" y="408780"/>
            <a:ext cx="1645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2CA3B75F-4BC9-4D8A-8FE9-293692F5CBA2}"/>
              </a:ext>
            </a:extLst>
          </p:cNvPr>
          <p:cNvCxnSpPr>
            <a:cxnSpLocks/>
          </p:cNvCxnSpPr>
          <p:nvPr/>
        </p:nvCxnSpPr>
        <p:spPr>
          <a:xfrm>
            <a:off x="3633216" y="2175814"/>
            <a:ext cx="1645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C9741877-886A-4B50-9E46-897FDC88339B}"/>
              </a:ext>
            </a:extLst>
          </p:cNvPr>
          <p:cNvSpPr txBox="1"/>
          <p:nvPr/>
        </p:nvSpPr>
        <p:spPr>
          <a:xfrm>
            <a:off x="4829114" y="769945"/>
            <a:ext cx="9712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4 (4.3 nm)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0A09D013-61DE-44E1-8B76-520BE119946B}"/>
              </a:ext>
            </a:extLst>
          </p:cNvPr>
          <p:cNvCxnSpPr>
            <a:cxnSpLocks/>
            <a:stCxn id="38" idx="0"/>
          </p:cNvCxnSpPr>
          <p:nvPr/>
        </p:nvCxnSpPr>
        <p:spPr>
          <a:xfrm flipH="1" flipV="1">
            <a:off x="5245929" y="424021"/>
            <a:ext cx="0" cy="345924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07339A00-E472-4918-AF82-31FC61C9E1B8}"/>
              </a:ext>
            </a:extLst>
          </p:cNvPr>
          <p:cNvCxnSpPr>
            <a:cxnSpLocks/>
            <a:stCxn id="38" idx="2"/>
          </p:cNvCxnSpPr>
          <p:nvPr/>
        </p:nvCxnSpPr>
        <p:spPr>
          <a:xfrm flipH="1">
            <a:off x="5245929" y="1031555"/>
            <a:ext cx="0" cy="1131055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EC0AAF1-088F-4A78-BEA4-1D203AFD2A2A}"/>
              </a:ext>
            </a:extLst>
          </p:cNvPr>
          <p:cNvCxnSpPr>
            <a:cxnSpLocks/>
          </p:cNvCxnSpPr>
          <p:nvPr/>
        </p:nvCxnSpPr>
        <p:spPr>
          <a:xfrm>
            <a:off x="3633216" y="51815"/>
            <a:ext cx="22067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99563D9D-716B-4F59-9C0A-6127A1E36BF6}"/>
              </a:ext>
            </a:extLst>
          </p:cNvPr>
          <p:cNvSpPr txBox="1"/>
          <p:nvPr/>
        </p:nvSpPr>
        <p:spPr>
          <a:xfrm>
            <a:off x="5279136" y="1356262"/>
            <a:ext cx="9712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6 (6.7 nm)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E827061F-AD1B-4DE5-9CA4-BADBB38A31FA}"/>
              </a:ext>
            </a:extLst>
          </p:cNvPr>
          <p:cNvCxnSpPr>
            <a:cxnSpLocks/>
          </p:cNvCxnSpPr>
          <p:nvPr/>
        </p:nvCxnSpPr>
        <p:spPr>
          <a:xfrm>
            <a:off x="3633216" y="2534816"/>
            <a:ext cx="21579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A7AC1F45-55C2-4A86-9FAE-382983AFA06F}"/>
              </a:ext>
            </a:extLst>
          </p:cNvPr>
          <p:cNvCxnSpPr>
            <a:stCxn id="49" idx="2"/>
          </p:cNvCxnSpPr>
          <p:nvPr/>
        </p:nvCxnSpPr>
        <p:spPr>
          <a:xfrm flipH="1">
            <a:off x="5764749" y="1617872"/>
            <a:ext cx="1" cy="916944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9D437A4B-4F35-4020-B072-F1A5870F8C33}"/>
              </a:ext>
            </a:extLst>
          </p:cNvPr>
          <p:cNvCxnSpPr>
            <a:cxnSpLocks/>
            <a:stCxn id="49" idx="0"/>
          </p:cNvCxnSpPr>
          <p:nvPr/>
        </p:nvCxnSpPr>
        <p:spPr>
          <a:xfrm flipH="1" flipV="1">
            <a:off x="5764749" y="82296"/>
            <a:ext cx="1" cy="1273966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35686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57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Liaw</dc:creator>
  <cp:lastModifiedBy>Kevin Liaw</cp:lastModifiedBy>
  <cp:revision>12</cp:revision>
  <dcterms:created xsi:type="dcterms:W3CDTF">2020-02-07T23:45:21Z</dcterms:created>
  <dcterms:modified xsi:type="dcterms:W3CDTF">2020-03-24T22:49:36Z</dcterms:modified>
</cp:coreProperties>
</file>